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3" r:id="rId3"/>
    <p:sldId id="266" r:id="rId4"/>
    <p:sldId id="265" r:id="rId5"/>
    <p:sldId id="264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01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0/05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5832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1873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23121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74429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0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tiff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tiff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tiff"/><Relationship Id="rId4" Type="http://schemas.openxmlformats.org/officeDocument/2006/relationships/hyperlink" Target="http://creativecommons.org/licenses/by/4.0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tiff"/><Relationship Id="rId4" Type="http://schemas.openxmlformats.org/officeDocument/2006/relationships/hyperlink" Target="http://creativecommons.org/licenses/by/4.0/" TargetMode="Externa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tiff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athogenesis of DKA and HH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EC09ABF-70E0-96A4-9BBF-0BE6CDD54A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5664" y="896675"/>
            <a:ext cx="6148695" cy="483658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Umpierrez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83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American Diabetes Association and European Association for the Study of Diabetes 2024. Distributed                                     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7289335" y="6021288"/>
            <a:ext cx="1675152" cy="474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he diagnosis criteria of DKA and HHS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2218270C-A1C9-225F-53D4-001ED10E9D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556" y="1671803"/>
            <a:ext cx="7992888" cy="31253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B2DE87C-2ED5-E2FD-F8CB-7D8CEA351C83}"/>
              </a:ext>
            </a:extLst>
          </p:cNvPr>
          <p:cNvSpPr txBox="1"/>
          <p:nvPr/>
        </p:nvSpPr>
        <p:spPr>
          <a:xfrm>
            <a:off x="395536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Umpierrez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83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American Diabetes Association and European Association for the Study of Diabetes 2024. Distributed                                     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3" name="Picture 2" descr="diabetologia logo.tif">
            <a:extLst>
              <a:ext uri="{FF2B5EF4-FFF2-40B4-BE49-F238E27FC236}">
                <a16:creationId xmlns:a16="http://schemas.microsoft.com/office/drawing/2014/main" id="{36FE63BE-ED63-EC9A-FAA5-83A736272B22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7289335" y="6021288"/>
            <a:ext cx="1675152" cy="474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1328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Clinical presentation in patients with DKA and HH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9CD0C6-12E7-D2E1-9EB5-45DA3610DF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7569" y="1699242"/>
            <a:ext cx="7508862" cy="331393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4CCC740-D51A-472F-DBAE-D001A0BEF2B1}"/>
              </a:ext>
            </a:extLst>
          </p:cNvPr>
          <p:cNvSpPr txBox="1"/>
          <p:nvPr/>
        </p:nvSpPr>
        <p:spPr>
          <a:xfrm>
            <a:off x="395536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Umpierrez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83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American Diabetes Association and European Association for the Study of Diabetes 2024. Distributed                                     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6" name="Picture 5" descr="diabetologia logo.tif">
            <a:extLst>
              <a:ext uri="{FF2B5EF4-FFF2-40B4-BE49-F238E27FC236}">
                <a16:creationId xmlns:a16="http://schemas.microsoft.com/office/drawing/2014/main" id="{371E01A7-4072-58D2-E411-12FBF2B7FAC6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7289335" y="6021288"/>
            <a:ext cx="1675152" cy="474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3832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523A86C-54CD-D8DB-EA97-24DC955785B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89"/>
          <a:stretch/>
        </p:blipFill>
        <p:spPr>
          <a:xfrm>
            <a:off x="1164386" y="808740"/>
            <a:ext cx="6800864" cy="49965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reatment pathways for DKA and HH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1AD99D7-FB4E-3630-3B22-2A14646092BD}"/>
              </a:ext>
            </a:extLst>
          </p:cNvPr>
          <p:cNvSpPr txBox="1"/>
          <p:nvPr/>
        </p:nvSpPr>
        <p:spPr>
          <a:xfrm>
            <a:off x="395536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Umpierrez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83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American Diabetes Association and European Association for the Study of Diabetes 2024. Distributed                                     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6" name="Picture 5" descr="diabetologia logo.tif">
            <a:extLst>
              <a:ext uri="{FF2B5EF4-FFF2-40B4-BE49-F238E27FC236}">
                <a16:creationId xmlns:a16="http://schemas.microsoft.com/office/drawing/2014/main" id="{5564E9AF-C634-278C-0A63-BC25B4832988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7289335" y="6021288"/>
            <a:ext cx="1675152" cy="474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22340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5CBBD53C-74D2-2082-1040-53E024840A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487" y="770164"/>
            <a:ext cx="7802772" cy="518452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ransition to maintenance insulin administration in DK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0697176-A11F-A829-89A4-F8012B4BB370}"/>
              </a:ext>
            </a:extLst>
          </p:cNvPr>
          <p:cNvSpPr txBox="1"/>
          <p:nvPr/>
        </p:nvSpPr>
        <p:spPr>
          <a:xfrm>
            <a:off x="395536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Umpierrez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83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American Diabetes Association and European Association for the Study of Diabetes 2024. Distributed                                     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6" name="Picture 5" descr="diabetologia logo.tif">
            <a:extLst>
              <a:ext uri="{FF2B5EF4-FFF2-40B4-BE49-F238E27FC236}">
                <a16:creationId xmlns:a16="http://schemas.microsoft.com/office/drawing/2014/main" id="{CA93CBD2-5036-AA64-E3D4-F483F44C3D18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7289335" y="6021288"/>
            <a:ext cx="1675152" cy="474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5763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</TotalTime>
  <Words>283</Words>
  <Application>Microsoft Office PowerPoint</Application>
  <PresentationFormat>On-screen Show (4:3)</PresentationFormat>
  <Paragraphs>30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8</cp:revision>
  <dcterms:created xsi:type="dcterms:W3CDTF">2016-06-15T12:53:43Z</dcterms:created>
  <dcterms:modified xsi:type="dcterms:W3CDTF">2024-05-30T09:38:21Z</dcterms:modified>
</cp:coreProperties>
</file>